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1554" y="-3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1F0EC-7609-428B-BBC5-1BD6AB8BA745}" type="datetimeFigureOut">
              <a:rPr lang="zh-CN" altLang="en-US" smtClean="0"/>
              <a:t>2025/6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79341E-A38E-4B07-B217-6CF00FE9C73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333" y="1655233"/>
            <a:ext cx="2160000" cy="108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166" y="1655233"/>
            <a:ext cx="2160000" cy="108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66" y="437037"/>
            <a:ext cx="2160000" cy="108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932" y="506135"/>
            <a:ext cx="2160000" cy="108000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5632" y="437037"/>
            <a:ext cx="1080000" cy="108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1682" y="1613330"/>
            <a:ext cx="1080000" cy="108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265" y="1613330"/>
            <a:ext cx="1080000" cy="108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1682" y="451534"/>
            <a:ext cx="1080000" cy="10800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932" y="5384661"/>
            <a:ext cx="2160000" cy="108000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66" y="4059947"/>
            <a:ext cx="2160000" cy="1080000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932" y="4108200"/>
            <a:ext cx="2160000" cy="108000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66" y="2735233"/>
            <a:ext cx="2160000" cy="108000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7166" y="2735233"/>
            <a:ext cx="2160000" cy="1080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966" y="5384661"/>
            <a:ext cx="2160000" cy="108000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265" y="4055569"/>
            <a:ext cx="1080000" cy="108000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333" y="2836638"/>
            <a:ext cx="1080000" cy="108000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265" y="2855401"/>
            <a:ext cx="1080000" cy="1080000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8596" y="5384661"/>
            <a:ext cx="1080000" cy="1080000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9497" y="5261212"/>
            <a:ext cx="1080000" cy="1080000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8596" y="4055569"/>
            <a:ext cx="1080000" cy="108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0750FF-5986-617A-0931-A5B7AC298E92}"/>
              </a:ext>
            </a:extLst>
          </p:cNvPr>
          <p:cNvSpPr txBox="1"/>
          <p:nvPr/>
        </p:nvSpPr>
        <p:spPr>
          <a:xfrm>
            <a:off x="482600" y="6699250"/>
            <a:ext cx="59817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: Manhattan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Q-Q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s of GWAS for the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GY, RBM, RTGN and RSF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 the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GIC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opulations.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Horizontal lines represent the </a:t>
            </a:r>
            <a:r>
              <a:rPr lang="en-US" sz="12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ignificance threshold</a:t>
            </a:r>
            <a:r>
              <a:rPr lang="en-US" sz="120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</TotalTime>
  <Words>30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来圆 翟</dc:creator>
  <cp:lastModifiedBy>MDPI</cp:lastModifiedBy>
  <cp:revision>4</cp:revision>
  <dcterms:created xsi:type="dcterms:W3CDTF">2025-02-10T09:02:00Z</dcterms:created>
  <dcterms:modified xsi:type="dcterms:W3CDTF">2025-06-16T01:36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AD749D059FF4BCFAC69DF872651B026_12</vt:lpwstr>
  </property>
  <property fmtid="{D5CDD505-2E9C-101B-9397-08002B2CF9AE}" pid="3" name="KSOProductBuildVer">
    <vt:lpwstr>2052-12.1.0.20784</vt:lpwstr>
  </property>
</Properties>
</file>